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619"/>
    <p:restoredTop sz="92197"/>
  </p:normalViewPr>
  <p:slideViewPr>
    <p:cSldViewPr snapToGrid="0" snapToObjects="1">
      <p:cViewPr varScale="1">
        <p:scale>
          <a:sx n="56" d="100"/>
          <a:sy n="56" d="100"/>
        </p:scale>
        <p:origin x="69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AD7162-6EA6-5946-8786-EB572FC3FE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9A0DAE8-523E-2F4A-895D-84799FE75C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0630C11-EAC0-4440-B97B-128243A42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E1EA170-365A-3C4B-B348-E9998FFF9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66C4606-6AAF-1349-9808-5D51FC1D5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8974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FC009B2-5264-1D4C-8BF6-8DB5C7064A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8382361-2814-2448-8C28-9A126934FB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43F347D-85EA-A248-BA27-FBCE10D47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64E9B64-8010-ED48-9AA3-CFF3B9876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E2035B-118D-F54A-BA24-28CBB2B36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48639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7338A2E-F74A-8942-B02E-C4F00F8869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BB4A73B-CC25-A745-9C86-78BAA3D8EC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00D4ADB-4056-5546-AE22-C40324D35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913A4D9-9C46-144B-BFE5-E9023A986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1EFACCF-0661-FF45-A55D-BF73B037BD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15626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EA3111-DE11-E545-9AE1-E09E328196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A217C79-F1AD-2A42-9390-39977350CE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9B3F9BC-EF95-2B4B-BB5C-CA7CF58B5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7F0C061-0FF9-D349-AAB5-5236911C6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9864966-A00C-BE4B-B90E-93D5F0D71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7503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68DD1A-1A05-F24E-A757-C5E965780F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CC96BAF-FDB0-024C-8418-601F6FA72C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C27A8AA-A280-3F43-BBAC-A2E6FCA7C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9DE8EA1-A14A-8549-ADBF-F7E87C0851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23EB3F-18F9-1142-AD9E-9ECED6B41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9492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09CC46-7179-D349-A1D1-3CD5F35BD9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3158AA1-2C25-2F4A-B457-6E5DCEB6E0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9957F92-4CFC-694D-AEB7-6FE1AB01D5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B440521-F5CA-5C44-91D4-DE2059C80E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F96B49C-CAF5-5440-A643-A3680EB49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77C10D9-8717-8E40-BF94-9F9FA818C0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3921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EB26B8-E38E-F646-9620-DF7C0D16AA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60EEDC0-7496-444D-A04A-B825C7A635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2ABCDBD-1EC3-8E47-9CD5-A5077C7666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0683966-DE0B-0140-888A-0CCA85FA64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26B6405-241E-C64C-88B6-91CC4F73595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8FB7044-B213-8A46-95E8-0D0B32D2B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A4332A2-C565-754E-956C-14FDDA1EC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049C3FD-B3C6-3946-8CF1-4A2A8CBC15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606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801C81-0F24-8F4A-AB15-AB18C5FC4B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49748CA-5EC7-8948-900A-66FBE4F9F1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904C2FE-6692-F94F-B030-468C4D6E84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031C042-D0C0-2149-9713-B594B6007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564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20DCAC3-9BE7-0B4B-96B3-57D450E96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819A78F-D0F0-5A41-8999-791084A75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7848F5A-C4AE-6544-BFE8-769FEF5211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7628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C3FF58-DEAC-0A49-8411-880691A146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D10BDC2-B33F-3349-963A-50FA0A53CD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A038DAC-A517-914D-86F2-F53F3A2892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9FCBDC3-806D-7642-9BE5-200338486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91C9485-2695-6543-B699-20B4A657E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AE39647-DFB2-ED4F-9B55-C5163384B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7156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C182D4-1088-2045-AE84-E7FFA90B6D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ABCA0E7-3EB2-C149-AA8B-11281A5025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/>
              <a:t>アイコンをクリックして図を追加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7553001-E5F4-A44E-9131-1681673F3E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7B02DB4-55A3-1C40-9868-FBB323C4E7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B4294C7-1960-CF43-B825-7B6A2234C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ED9F578-407D-7C45-9E0D-3CA771C824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25064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FDAE1B3-A09B-1B48-A297-8E01EB0093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8944210-8667-2045-92F8-82F4A2D7EF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111550D-6142-2C4C-84F8-1AF4EBC509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Meiryo" panose="020B0604030504040204" pitchFamily="34" charset="-128"/>
                <a:ea typeface="Meiryo" panose="020B0604030504040204" pitchFamily="34" charset="-128"/>
              </a:defRPr>
            </a:lvl1pPr>
          </a:lstStyle>
          <a:p>
            <a:fld id="{46F1C488-BCE3-504D-83AE-3D10181D5E1D}" type="datetimeFigureOut">
              <a:rPr lang="ja-JP" altLang="en-US" smtClean="0"/>
              <a:pPr/>
              <a:t>2024/2/14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B30E0D6-FE9A-1849-8044-22B197E14B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Meiryo" panose="020B0604030504040204" pitchFamily="34" charset="-128"/>
                <a:ea typeface="Meiryo" panose="020B0604030504040204" pitchFamily="34" charset="-128"/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8B97180-1BBC-0049-A536-D9BA9879B9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Meiryo" panose="020B0604030504040204" pitchFamily="34" charset="-128"/>
                <a:ea typeface="Meiryo" panose="020B0604030504040204" pitchFamily="34" charset="-128"/>
              </a:defRPr>
            </a:lvl1pPr>
          </a:lstStyle>
          <a:p>
            <a:fld id="{69F0FFBC-D4C0-0A48-9985-962C9B3C4CB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75814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276FC0B-B83C-A148-93DC-0B4671192A00}"/>
              </a:ext>
            </a:extLst>
          </p:cNvPr>
          <p:cNvSpPr txBox="1"/>
          <p:nvPr/>
        </p:nvSpPr>
        <p:spPr>
          <a:xfrm>
            <a:off x="1516453" y="189145"/>
            <a:ext cx="111700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Changes in intact parathyroid hormone levels after denosumab administration</a:t>
            </a:r>
            <a:endParaRPr kumimoji="1" lang="ja-JP" altLang="en-US" sz="1600" u="sng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B05205D-9C1D-5E48-80D6-A9A4DE568DF5}"/>
              </a:ext>
            </a:extLst>
          </p:cNvPr>
          <p:cNvSpPr txBox="1"/>
          <p:nvPr/>
        </p:nvSpPr>
        <p:spPr>
          <a:xfrm rot="16200000">
            <a:off x="-366113" y="3028636"/>
            <a:ext cx="4134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act parathyroid hormone levels (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L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5143D8A-5A3E-5A4A-B998-8E8F56380CAF}"/>
              </a:ext>
            </a:extLst>
          </p:cNvPr>
          <p:cNvSpPr txBox="1"/>
          <p:nvPr/>
        </p:nvSpPr>
        <p:spPr>
          <a:xfrm>
            <a:off x="3692379" y="6239164"/>
            <a:ext cx="3871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th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after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nosumab administration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D1EC92A-6287-1C40-9652-42C2A3C480F9}"/>
              </a:ext>
            </a:extLst>
          </p:cNvPr>
          <p:cNvSpPr txBox="1"/>
          <p:nvPr/>
        </p:nvSpPr>
        <p:spPr>
          <a:xfrm>
            <a:off x="2446932" y="5847594"/>
            <a:ext cx="6782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           6            12           18            24           36           48           60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14B1A7DF-65A7-074C-A1F9-2D7B438AA4A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29" b="8254"/>
          <a:stretch/>
        </p:blipFill>
        <p:spPr>
          <a:xfrm>
            <a:off x="2027583" y="655914"/>
            <a:ext cx="7433328" cy="5114777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767320F-294F-2847-841A-B464F7D5F6CC}"/>
              </a:ext>
            </a:extLst>
          </p:cNvPr>
          <p:cNvSpPr txBox="1"/>
          <p:nvPr/>
        </p:nvSpPr>
        <p:spPr>
          <a:xfrm>
            <a:off x="785191" y="317058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4051713"/>
      </p:ext>
    </p:extLst>
  </p:cSld>
  <p:clrMapOvr>
    <a:masterClrMapping/>
  </p:clrMapOvr>
</p:sld>
</file>

<file path=ppt/theme/theme1.xml><?xml version="1.0" encoding="utf-8"?>
<a:theme xmlns:a="http://schemas.openxmlformats.org/drawingml/2006/main" name="テーマ1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テーマ1" id="{C9DF33FA-C216-FC4A-9A77-53C2FAB637B0}" vid="{D8C45B50-8ECB-684F-B49B-15C1275691BF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テーマ1</Template>
  <TotalTime>629</TotalTime>
  <Words>34</Words>
  <Application>Microsoft Macintosh PowerPoint</Application>
  <PresentationFormat>ワイド画面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Meiryo</vt:lpstr>
      <vt:lpstr>游ゴシック</vt:lpstr>
      <vt:lpstr>Arial</vt:lpstr>
      <vt:lpstr>Times New Roman</vt:lpstr>
      <vt:lpstr>テーマ1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加藤 一彦</dc:creator>
  <cp:lastModifiedBy>加藤 一彦</cp:lastModifiedBy>
  <cp:revision>96</cp:revision>
  <cp:lastPrinted>2023-12-21T08:00:09Z</cp:lastPrinted>
  <dcterms:created xsi:type="dcterms:W3CDTF">2023-10-10T05:47:52Z</dcterms:created>
  <dcterms:modified xsi:type="dcterms:W3CDTF">2024-02-14T02:57:26Z</dcterms:modified>
</cp:coreProperties>
</file>